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notesMasterIdLst>
    <p:notesMasterId r:id="rId6"/>
  </p:notesMasterIdLst>
  <p:sldIdLst>
    <p:sldId id="26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6113"/>
    <p:restoredTop sz="75170"/>
  </p:normalViewPr>
  <p:slideViewPr>
    <p:cSldViewPr snapToGrid="0">
      <p:cViewPr varScale="1">
        <p:scale>
          <a:sx n="56" d="100"/>
          <a:sy n="56" d="100"/>
        </p:scale>
        <p:origin x="84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B2F092-219F-A749-A590-CDC140B96318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A264F9-EA06-3548-A4E1-0703658F87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10386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r>
              <a:rPr lang="en-US" sz="12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2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ffect of </a:t>
            </a:r>
            <a:r>
              <a:rPr lang="en-US" sz="1200" i="1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f-</a:t>
            </a:r>
            <a:r>
              <a:rPr lang="en-US" sz="12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RBCs and RBCs on barrier tightness in hiPSC-derived BMECs over a period of 2, 4, 6, and 9 hours.</a:t>
            </a:r>
            <a:r>
              <a:rPr lang="en-US" sz="1200" b="1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ld change when </a:t>
            </a:r>
            <a:r>
              <a:rPr lang="en-US" sz="1200" kern="50" spc="-15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iPSC</a:t>
            </a:r>
            <a:r>
              <a:rPr lang="en-US" sz="12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derived BMECs were exposed to </a:t>
            </a:r>
            <a:r>
              <a:rPr lang="en-US" sz="1200" i="1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f-</a:t>
            </a:r>
            <a:r>
              <a:rPr lang="en-US" sz="1200" kern="50" spc="-15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RBC</a:t>
            </a:r>
            <a:r>
              <a:rPr lang="en-US" sz="12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RBCs in a ratio of 1:50, respectively.</a:t>
            </a: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2C13CCC-C203-394F-8D31-2DD52CC57F8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8569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7AF5C28-7AE3-BE79-E172-1F01E2023D0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26E38FB6-2093-54C4-774B-DEFCF095909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5B4E63F0-61B2-A143-4FB7-EA72D831A3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1F8C9-F2F9-9942-8BE5-29CCF4DA99FE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007C960-22C6-43F4-9A9E-24F24CA1C6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F5500A9E-E81B-513C-BD27-CC7060AFCD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192BB-9FEB-C740-9B72-35173F84A9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75428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A4483AB-7538-F845-BFFE-66FE68BF1D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14464B6C-BDEB-ED67-14D5-0826A0AC87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C95AE220-9954-E669-B375-891D27C0B5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1F8C9-F2F9-9942-8BE5-29CCF4DA99FE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9B61E4E3-04A0-816E-F780-9984DE83CD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6AAA998F-0AD0-669E-D546-50BD7B5F12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192BB-9FEB-C740-9B72-35173F84A9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29856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DC9C5238-E3A4-EA37-09AD-BE6EDBA7269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40012F7A-894B-60BE-17B5-2C89878A76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1597FE0-CBBC-032F-D1B0-8A7B926BFC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1F8C9-F2F9-9942-8BE5-29CCF4DA99FE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C8FAFF17-A583-2C8E-E545-672FB8C09E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4BB88BAA-94B2-2E20-60FD-C42A6424AD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192BB-9FEB-C740-9B72-35173F84A9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59592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92F135E-85A1-5F16-9708-3ADD06D340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A98EB2BA-E9C0-E982-5E44-DFC2599C8CE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BA107A03-3784-A60B-CDB2-CEDA809A00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1F8C9-F2F9-9942-8BE5-29CCF4DA99FE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2DB4B1C-2951-9CC4-1B7A-AB8ECCFFA0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7AF088A-F76C-59F1-DAFC-8D77AE0567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192BB-9FEB-C740-9B72-35173F84A9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32330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74281C1-EE48-C31E-1428-2016C36248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14AF62EC-B85A-0962-3502-2D0A60CCB9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993B9FD6-3EE3-A618-2285-6A14E88185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1F8C9-F2F9-9942-8BE5-29CCF4DA99FE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3057A79B-A596-5247-DA1E-CDBDF3A114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A75BA89-7B62-1903-FD65-65E97FF00D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192BB-9FEB-C740-9B72-35173F84A9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98690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F9DFF86-85AB-7311-CAC0-647545B728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8A6175D3-EE0B-B064-D834-756185676BE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3F266684-CAD2-77CD-B02B-4C45646B4E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4B96C116-0219-CC0D-5AE7-0AAD88DB88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1F8C9-F2F9-9942-8BE5-29CCF4DA99FE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CD733B75-11D2-F998-669B-AAEBBF1B06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80CFCCA8-FF5D-36B6-2C40-B81D9BAAC6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192BB-9FEB-C740-9B72-35173F84A9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51902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B293B78-6B22-50F3-0443-D65BEA612C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B72FC8F8-2F75-4057-5A88-498948C8C2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3F08C01B-2434-6ED0-3B39-141037C72E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0918CBFF-49FC-409C-5753-8913152219D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C14B1082-2446-8A02-C5EC-6A5F925A876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277A3D4F-5E9B-17D2-1271-5BE5CFBB9D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1F8C9-F2F9-9942-8BE5-29CCF4DA99FE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3E05C041-1DCD-EC99-7032-334BC10A01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98198BA8-94CA-F77B-3279-176018BFB3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192BB-9FEB-C740-9B72-35173F84A9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9273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419BF22-D9EC-A7B0-BD9E-B1D4FDEDD2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E509FBDD-93E1-523D-44C4-CDE96CFF3A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1F8C9-F2F9-9942-8BE5-29CCF4DA99FE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0633D5ED-ECFB-0124-A1DD-BA0FAFD7E6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33E16C77-4941-E250-62A6-952233160C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192BB-9FEB-C740-9B72-35173F84A9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06131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F8FC6D4B-A588-BE1D-A805-F390E1D83A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1F8C9-F2F9-9942-8BE5-29CCF4DA99FE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94A57DF7-4160-AA4A-5EAE-DC9763211D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7F5839BE-7FCB-18A6-ACD3-1885EDAD86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192BB-9FEB-C740-9B72-35173F84A9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0540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0188BF1-37DB-5E44-FDCC-3610801A18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C171DB43-55CD-AEC2-821B-48327738FCE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FAEBB076-2741-CB9C-3277-F9CBF75708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3F68AB6C-3F81-C62D-654C-AE356E395B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1F8C9-F2F9-9942-8BE5-29CCF4DA99FE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4855FE3C-362D-8E93-6760-FEF1BE28F9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9D456880-30E1-3547-A2FE-5C01F08C28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192BB-9FEB-C740-9B72-35173F84A9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41051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504266B-95D6-F39B-C1E9-62C5D2BAE1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BFB7FE4F-CC9E-8EDE-D490-1AFA3C1C75C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B1B07F0E-9EBF-2176-7CEE-8764903304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EAC7C063-CE47-40D4-07C0-8077C0C153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1F8C9-F2F9-9942-8BE5-29CCF4DA99FE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9448FF7C-AAA6-7209-3CBB-77F4C5A061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D8A3C3D5-2FB1-5D2E-B740-247D3D6F2D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192BB-9FEB-C740-9B72-35173F84A9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75434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B5282980-CE87-4311-FBBA-DA0F3C5135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ACF178A6-592C-FE5D-876D-6D53C35B3F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276E747D-4AC3-91EF-35F3-AB5D3A694DE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3D1F8C9-F2F9-9942-8BE5-29CCF4DA99FE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CF75861-7E16-9516-3170-97F43CC7342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2D289141-2D0A-183B-37DC-F6937CB7975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97192BB-9FEB-C740-9B72-35173F84A9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50300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xmlns="" id="{423CAF85-D88F-B6CC-5098-F22622FC484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2542442" y="1798028"/>
            <a:ext cx="6504242" cy="2403742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346D64AC-A717-2D49-DD2F-01C07DEF7D26}"/>
              </a:ext>
            </a:extLst>
          </p:cNvPr>
          <p:cNvSpPr txBox="1"/>
          <p:nvPr/>
        </p:nvSpPr>
        <p:spPr>
          <a:xfrm>
            <a:off x="2542442" y="4852453"/>
            <a:ext cx="650424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0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ffect of </a:t>
            </a:r>
            <a:r>
              <a:rPr lang="en-US" sz="1000" i="1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f-</a:t>
            </a:r>
            <a:r>
              <a:rPr lang="en-US" sz="10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RBCs and RBCs on barrier tightness in hiPSC-derived BMECs over a period of 2, 4, 6, and 9 hours.</a:t>
            </a:r>
            <a:r>
              <a:rPr lang="en-US" sz="1000" b="1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0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ld change when hiPSC-derived BMECs were exposed to </a:t>
            </a:r>
            <a:r>
              <a:rPr lang="en-US" sz="1000" i="1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f-</a:t>
            </a:r>
            <a:r>
              <a:rPr lang="en-US" sz="10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RBC and RBCs in a ratio of 1:50, respectively.</a:t>
            </a:r>
            <a:endParaRPr lang="en-US" sz="10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999473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6F83623FE0101439BF9CBCA708448C2" ma:contentTypeVersion="14" ma:contentTypeDescription="Create a new document." ma:contentTypeScope="" ma:versionID="43435aca2c006b86cb5a1b4b69da5887">
  <xsd:schema xmlns:xsd="http://www.w3.org/2001/XMLSchema" xmlns:xs="http://www.w3.org/2001/XMLSchema" xmlns:p="http://schemas.microsoft.com/office/2006/metadata/properties" xmlns:ns2="88a897e8-d4da-4754-b76c-471f0d488363" xmlns:ns3="9a2030ed-2c9c-4ecf-96df-48ffd2037682" targetNamespace="http://schemas.microsoft.com/office/2006/metadata/properties" ma:root="true" ma:fieldsID="8e3ea8bdce2d7a53ced3a228efd8bbf6" ns2:_="" ns3:_="">
    <xsd:import namespace="88a897e8-d4da-4754-b76c-471f0d488363"/>
    <xsd:import namespace="9a2030ed-2c9c-4ecf-96df-48ffd2037682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ServiceSearchProperties" minOccurs="0"/>
                <xsd:element ref="ns2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8a897e8-d4da-4754-b76c-471f0d48836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lcf76f155ced4ddcb4097134ff3c332f" ma:index="13" nillable="true" ma:taxonomy="true" ma:internalName="lcf76f155ced4ddcb4097134ff3c332f" ma:taxonomyFieldName="MediaServiceImageTags" ma:displayName="Image Tags" ma:readOnly="false" ma:fieldId="{5cf76f15-5ced-4ddc-b409-7134ff3c332f}" ma:taxonomyMulti="true" ma:sspId="0eec0a79-46cb-4568-9b1b-2d720bd3207c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15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9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SearchProperties" ma:index="2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Location" ma:index="21" nillable="true" ma:displayName="Location" ma:indexed="true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a2030ed-2c9c-4ecf-96df-48ffd2037682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4" nillable="true" ma:displayName="Taxonomy Catch All Column" ma:hidden="true" ma:list="{d587f133-08ee-41ab-81b8-7455cffb4ef8}" ma:internalName="TaxCatchAll" ma:showField="CatchAllData" ma:web="9a2030ed-2c9c-4ecf-96df-48ffd2037682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88a897e8-d4da-4754-b76c-471f0d488363">
      <Terms xmlns="http://schemas.microsoft.com/office/infopath/2007/PartnerControls"/>
    </lcf76f155ced4ddcb4097134ff3c332f>
    <TaxCatchAll xmlns="9a2030ed-2c9c-4ecf-96df-48ffd2037682" xsi:nil="true"/>
  </documentManagement>
</p:properties>
</file>

<file path=customXml/itemProps1.xml><?xml version="1.0" encoding="utf-8"?>
<ds:datastoreItem xmlns:ds="http://schemas.openxmlformats.org/officeDocument/2006/customXml" ds:itemID="{05722EB1-9159-41FD-B526-27061F7AE9C7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DAF1823C-BB16-4EB6-A76D-FBAA9997B96B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8a897e8-d4da-4754-b76c-471f0d488363"/>
    <ds:schemaRef ds:uri="9a2030ed-2c9c-4ecf-96df-48ffd2037682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7B8834CC-FB41-4E58-9E6A-63E9B3D23FFA}">
  <ds:schemaRefs>
    <ds:schemaRef ds:uri="http://schemas.microsoft.com/office/2006/metadata/properties"/>
    <ds:schemaRef ds:uri="http://schemas.microsoft.com/office/infopath/2007/PartnerControls"/>
    <ds:schemaRef ds:uri="88a897e8-d4da-4754-b76c-471f0d488363"/>
    <ds:schemaRef ds:uri="9a2030ed-2c9c-4ecf-96df-48ffd2037682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95</Words>
  <Application>Microsoft Office PowerPoint</Application>
  <PresentationFormat>Widescreen</PresentationFormat>
  <Paragraphs>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pinadhan, Adnan</dc:creator>
  <cp:lastModifiedBy>Maria Flora V.</cp:lastModifiedBy>
  <cp:revision>3</cp:revision>
  <dcterms:created xsi:type="dcterms:W3CDTF">2024-04-11T16:51:09Z</dcterms:created>
  <dcterms:modified xsi:type="dcterms:W3CDTF">2024-04-20T11:57:2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46F83623FE0101439BF9CBCA708448C2</vt:lpwstr>
  </property>
</Properties>
</file>